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1563" autoAdjust="0"/>
  </p:normalViewPr>
  <p:slideViewPr>
    <p:cSldViewPr snapToObjects="1">
      <p:cViewPr varScale="1">
        <p:scale>
          <a:sx n="64" d="100"/>
          <a:sy n="64" d="100"/>
        </p:scale>
        <p:origin x="-1848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B65518-0818-4DD1-B3B3-F9DC88F4186F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3CD556-71AC-4445-AC48-7E1B081BE9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830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: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mages of individual siliques point inoculated at the cut tip. (a-c) Water inoculated controls show comparable development and seed set between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ds1-2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mr1-1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mr1-2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otypes. (d-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Comparable levels of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sarium culmorum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fection of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mr1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tant and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ds1-2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liques 7 days post inoculation. In panels d through f, whole infected split (left) and intact (right) siliques are shown. In panels g through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e close-up images of infected seeds. Shown are representative images present in multiple biological replicates.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13CD556-71AC-4445-AC48-7E1B081BE91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87494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9515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2631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8389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3254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336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056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105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7689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4699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472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4901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08F7F-8B1A-4732-9526-94B7FC63C65C}" type="datetimeFigureOut">
              <a:rPr lang="en-GB" smtClean="0"/>
              <a:t>12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90B3EC-5643-4C92-8223-086B6AAC8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3204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jpe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7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8" r="34058"/>
          <a:stretch/>
        </p:blipFill>
        <p:spPr bwMode="auto">
          <a:xfrm>
            <a:off x="4151810" y="207430"/>
            <a:ext cx="936000" cy="27708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3" y="215498"/>
            <a:ext cx="1179121" cy="2762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25559" y="8145823"/>
            <a:ext cx="15518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i="1" dirty="0" smtClean="0"/>
              <a:t>dmr1-2</a:t>
            </a:r>
            <a:endParaRPr lang="en-GB" sz="2400" b="1" i="1" dirty="0"/>
          </a:p>
        </p:txBody>
      </p:sp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1266" y="215498"/>
            <a:ext cx="826190" cy="2762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6567" y="215499"/>
            <a:ext cx="972447" cy="27628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0808" y="210348"/>
            <a:ext cx="913775" cy="2767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40843" y="8145823"/>
            <a:ext cx="14937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i="1" dirty="0" smtClean="0"/>
              <a:t>dmr1-1</a:t>
            </a:r>
            <a:endParaRPr lang="en-GB" sz="2400" b="1" i="1" dirty="0"/>
          </a:p>
        </p:txBody>
      </p:sp>
      <p:pic>
        <p:nvPicPr>
          <p:cNvPr id="10" name="Picture 6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635"/>
          <a:stretch/>
        </p:blipFill>
        <p:spPr bwMode="auto">
          <a:xfrm>
            <a:off x="3309568" y="210347"/>
            <a:ext cx="900000" cy="27637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3309566" y="8145823"/>
            <a:ext cx="17782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i="1" dirty="0" smtClean="0"/>
              <a:t>eds1-2</a:t>
            </a:r>
            <a:endParaRPr lang="en-GB" sz="2400" b="1" i="1" dirty="0"/>
          </a:p>
        </p:txBody>
      </p:sp>
      <p:pic>
        <p:nvPicPr>
          <p:cNvPr id="13" name="Picture 8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3" y="3043076"/>
            <a:ext cx="830123" cy="2767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9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1665" y="3043076"/>
            <a:ext cx="795790" cy="2767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11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0843" y="3043076"/>
            <a:ext cx="1508958" cy="2767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1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9568" y="3043076"/>
            <a:ext cx="1110819" cy="2769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13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09739" y="3043076"/>
            <a:ext cx="978071" cy="2767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14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3" y="5851881"/>
            <a:ext cx="1560822" cy="22939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049"/>
          <a:stretch/>
        </p:blipFill>
        <p:spPr bwMode="auto">
          <a:xfrm>
            <a:off x="1740843" y="5861168"/>
            <a:ext cx="1512000" cy="2284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8772" y="5861168"/>
            <a:ext cx="1769038" cy="2284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16632" y="2579011"/>
            <a:ext cx="21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56567" y="2619511"/>
            <a:ext cx="21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b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25559" y="5419691"/>
            <a:ext cx="21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d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309568" y="5434157"/>
            <a:ext cx="21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f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25559" y="7757542"/>
            <a:ext cx="21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g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309566" y="2579011"/>
            <a:ext cx="21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c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40843" y="5405157"/>
            <a:ext cx="21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740262" y="7776491"/>
            <a:ext cx="21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h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309565" y="7768500"/>
            <a:ext cx="21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i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5087810" y="-2231"/>
            <a:ext cx="1760082" cy="47089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i="1" dirty="0"/>
              <a:t>Supplementary Figure 1:</a:t>
            </a:r>
            <a:r>
              <a:rPr lang="en-GB" sz="1200" dirty="0"/>
              <a:t> Images of individual siliques point inoculated at the cut tip. (a-c) Water inoculated controls show comparable development and seed set between </a:t>
            </a:r>
            <a:r>
              <a:rPr lang="en-GB" sz="1200" i="1" dirty="0"/>
              <a:t>eds1-2 </a:t>
            </a:r>
            <a:r>
              <a:rPr lang="en-GB" sz="1200" dirty="0"/>
              <a:t>and </a:t>
            </a:r>
            <a:r>
              <a:rPr lang="en-GB" sz="1200" i="1" dirty="0"/>
              <a:t>dmr1-1 </a:t>
            </a:r>
            <a:r>
              <a:rPr lang="en-GB" sz="1200" dirty="0"/>
              <a:t>and </a:t>
            </a:r>
            <a:r>
              <a:rPr lang="en-GB" sz="1200" i="1" dirty="0"/>
              <a:t>dmr1-2 </a:t>
            </a:r>
            <a:r>
              <a:rPr lang="en-GB" sz="1200" dirty="0"/>
              <a:t>genotypes. (d-</a:t>
            </a:r>
            <a:r>
              <a:rPr lang="en-GB" sz="1200" dirty="0" err="1"/>
              <a:t>i</a:t>
            </a:r>
            <a:r>
              <a:rPr lang="en-GB" sz="1200" dirty="0"/>
              <a:t>) Comparable levels of </a:t>
            </a:r>
            <a:r>
              <a:rPr lang="en-GB" sz="1200" i="1" dirty="0"/>
              <a:t>Fusarium culmorum</a:t>
            </a:r>
            <a:r>
              <a:rPr lang="en-GB" sz="1200" dirty="0"/>
              <a:t> infection of </a:t>
            </a:r>
            <a:r>
              <a:rPr lang="en-GB" sz="1200" i="1" dirty="0"/>
              <a:t>dmr1 </a:t>
            </a:r>
            <a:r>
              <a:rPr lang="en-GB" sz="1200" dirty="0"/>
              <a:t>mutant and </a:t>
            </a:r>
            <a:r>
              <a:rPr lang="en-GB" sz="1200" i="1" dirty="0"/>
              <a:t>eds1-2 </a:t>
            </a:r>
            <a:r>
              <a:rPr lang="en-GB" sz="1200" dirty="0"/>
              <a:t>siliques 7 days post inoculation. In panels d through f, whole infected split (left) and intact (right) siliques are shown. In panels g through </a:t>
            </a:r>
            <a:r>
              <a:rPr lang="en-GB" sz="1200" dirty="0" err="1"/>
              <a:t>i</a:t>
            </a:r>
            <a:r>
              <a:rPr lang="en-GB" sz="1200" dirty="0"/>
              <a:t> are close-up images of infected seeds. </a:t>
            </a:r>
            <a:r>
              <a:rPr lang="en-GB" sz="1200"/>
              <a:t>Shown are representative images present in multiple biological replicates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626421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</TotalTime>
  <Words>209</Words>
  <Application>Microsoft Office PowerPoint</Application>
  <PresentationFormat>On-screen Show 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Brewer (RRes-Roth)</dc:creator>
  <cp:lastModifiedBy>Helen Brewer (RRes-Roth)</cp:lastModifiedBy>
  <cp:revision>11</cp:revision>
  <dcterms:created xsi:type="dcterms:W3CDTF">2013-07-22T16:35:34Z</dcterms:created>
  <dcterms:modified xsi:type="dcterms:W3CDTF">2014-09-12T09:19:21Z</dcterms:modified>
</cp:coreProperties>
</file>